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6" r:id="rId2"/>
    <p:sldId id="267" r:id="rId3"/>
    <p:sldId id="265" r:id="rId4"/>
    <p:sldId id="264" r:id="rId5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Abschnitt ohne Titel" id="{1C24FB27-EAC9-4888-8986-AB5B504C8AEC}">
          <p14:sldIdLst>
            <p14:sldId id="266"/>
            <p14:sldId id="267"/>
            <p14:sldId id="265"/>
            <p14:sldId id="26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ertero, Edoardo" initials="BE" lastIdx="2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16" autoAdjust="0"/>
    <p:restoredTop sz="94667" autoAdjust="0"/>
  </p:normalViewPr>
  <p:slideViewPr>
    <p:cSldViewPr>
      <p:cViewPr varScale="1">
        <p:scale>
          <a:sx n="79" d="100"/>
          <a:sy n="79" d="100"/>
        </p:scale>
        <p:origin x="3240" y="11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66438F-83CA-4B41-9178-E19DA094E9F5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8B8496-D860-44EB-9183-6C974E4FE2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84144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8B8496-D860-44EB-9183-6C974E4FE2D3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61532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134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2500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4895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5616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1390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1775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5343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4963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6415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0946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8087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3FC19-6976-4EE8-8564-479C79119B93}" type="datetimeFigureOut">
              <a:rPr lang="de-DE" smtClean="0"/>
              <a:t>29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862BC-CEDE-44E3-BB0C-5402C5C463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6583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9156332"/>
              </p:ext>
            </p:extLst>
          </p:nvPr>
        </p:nvGraphicFramePr>
        <p:xfrm>
          <a:off x="393700" y="2051720"/>
          <a:ext cx="6411913" cy="2282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054" name="Prism 7" r:id="rId4" imgW="7750841" imgH="2761301" progId="Prism7.Document">
                  <p:embed/>
                </p:oleObj>
              </mc:Choice>
              <mc:Fallback>
                <p:oleObj name="Prism 7" r:id="rId4" imgW="7750841" imgH="2761301" progId="Prism7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3700" y="2051720"/>
                        <a:ext cx="6411913" cy="2282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0546918"/>
              </p:ext>
            </p:extLst>
          </p:nvPr>
        </p:nvGraphicFramePr>
        <p:xfrm>
          <a:off x="394790" y="5308625"/>
          <a:ext cx="6508750" cy="2071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055" name="Prism 7" r:id="rId6" imgW="7917224" imgH="2517117" progId="Prism7.Document">
                  <p:embed/>
                </p:oleObj>
              </mc:Choice>
              <mc:Fallback>
                <p:oleObj name="Prism 7" r:id="rId6" imgW="7917224" imgH="2517117" progId="Prism7.Document">
                  <p:embed/>
                  <p:pic>
                    <p:nvPicPr>
                      <p:cNvPr id="91" name="Objekt 9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4790" y="5308625"/>
                        <a:ext cx="6508750" cy="2071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1876331" y="0"/>
            <a:ext cx="3105337" cy="40011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sz="20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 rot="16200000">
            <a:off x="-560720" y="2186937"/>
            <a:ext cx="17572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/6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tochondria</a:t>
            </a:r>
          </a:p>
        </p:txBody>
      </p:sp>
      <p:sp>
        <p:nvSpPr>
          <p:cNvPr id="8" name="Textfeld 7"/>
          <p:cNvSpPr txBox="1"/>
          <p:nvPr/>
        </p:nvSpPr>
        <p:spPr>
          <a:xfrm rot="16200000">
            <a:off x="-534476" y="5359743"/>
            <a:ext cx="1717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/6J mitochondri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1414593" y="470556"/>
            <a:ext cx="16466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bstrate(s) alon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006881" y="467544"/>
            <a:ext cx="20681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bstrate(s) + rotenon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86941" y="648936"/>
            <a:ext cx="263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9414" y="400318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08720" y="970090"/>
            <a:ext cx="5633290" cy="1209579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08720" y="4226518"/>
            <a:ext cx="5633290" cy="1209578"/>
          </a:xfrm>
          <a:prstGeom prst="rect">
            <a:avLst/>
          </a:prstGeom>
        </p:spPr>
      </p:pic>
      <p:sp>
        <p:nvSpPr>
          <p:cNvPr id="15" name="Rechteck 14"/>
          <p:cNvSpPr/>
          <p:nvPr/>
        </p:nvSpPr>
        <p:spPr>
          <a:xfrm>
            <a:off x="548680" y="7354178"/>
            <a:ext cx="5688632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rect comparison of traces shown in </a:t>
            </a:r>
            <a:r>
              <a: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1a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100" b="1" dirty="0">
                <a:solidFill>
                  <a:srgbClr val="0070C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a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H</a:t>
            </a:r>
            <a:r>
              <a:rPr lang="en-US" sz="1100" baseline="-25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100" baseline="-25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mission (by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plex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®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ltraRed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f isolated cardiac mitochondria harvested from BL/6N (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r BL/6J (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ice with preserved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oxidative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apacity (solid lines) or after treatment with DNCB (dashed lines). Pyruvate and malate (5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ach, black traces) or α-ketoglutarate (5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green traces) were used as substrates, and H</a:t>
            </a:r>
            <a:r>
              <a:rPr lang="en-US" sz="1100" baseline="-25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100" baseline="-25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mission was measured in the presence of vehicle (left part) or rotenone (right part).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073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876331" y="0"/>
            <a:ext cx="3105337" cy="40011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US" sz="20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5818422"/>
              </p:ext>
            </p:extLst>
          </p:nvPr>
        </p:nvGraphicFramePr>
        <p:xfrm>
          <a:off x="1260127" y="682625"/>
          <a:ext cx="4329113" cy="2593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9" name="Prism 7" r:id="rId3" imgW="8475074" imgH="5075651" progId="Prism7.Document">
                  <p:embed/>
                </p:oleObj>
              </mc:Choice>
              <mc:Fallback>
                <p:oleObj name="Prism 7" r:id="rId3" imgW="8475074" imgH="507565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60127" y="682625"/>
                        <a:ext cx="4329113" cy="2593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1472629" y="530260"/>
            <a:ext cx="263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873579" y="530260"/>
            <a:ext cx="263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548680" y="3505165"/>
            <a:ext cx="576064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zymatic activity of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itrate synthase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onitase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in cardiac mitochondria of BL/6N and BL/6J mice.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ce was calculated using Student’s t-test.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850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876331" y="0"/>
            <a:ext cx="3105337" cy="40011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en-US" sz="20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0992716"/>
              </p:ext>
            </p:extLst>
          </p:nvPr>
        </p:nvGraphicFramePr>
        <p:xfrm>
          <a:off x="-27384" y="3635896"/>
          <a:ext cx="6896175" cy="20074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070" name="Prism 7" r:id="rId3" imgW="9243603" imgH="2695753" progId="Prism7.Document">
                  <p:embed/>
                </p:oleObj>
              </mc:Choice>
              <mc:Fallback>
                <p:oleObj name="Prism 7" r:id="rId3" imgW="9243603" imgH="2695753" progId="Prism7.Document">
                  <p:embed/>
                  <p:pic>
                    <p:nvPicPr>
                      <p:cNvPr id="6" name="Objekt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27384" y="3635896"/>
                        <a:ext cx="6896175" cy="20074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2422766"/>
              </p:ext>
            </p:extLst>
          </p:nvPr>
        </p:nvGraphicFramePr>
        <p:xfrm>
          <a:off x="1006251" y="757238"/>
          <a:ext cx="4799013" cy="2733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071" name="Prism 7" r:id="rId5" imgW="9476611" imgH="5398709" progId="Prism7.Document">
                  <p:embed/>
                </p:oleObj>
              </mc:Choice>
              <mc:Fallback>
                <p:oleObj name="Prism 7" r:id="rId5" imgW="9476611" imgH="539870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06251" y="757238"/>
                        <a:ext cx="4799013" cy="2733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1118973" y="720944"/>
            <a:ext cx="263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398543" y="720944"/>
            <a:ext cx="263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72047" y="3491880"/>
            <a:ext cx="263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2044255" y="3491880"/>
            <a:ext cx="263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556423" y="3491880"/>
            <a:ext cx="263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" name="Rechteck 1"/>
          <p:cNvSpPr/>
          <p:nvPr/>
        </p:nvSpPr>
        <p:spPr>
          <a:xfrm>
            <a:off x="548680" y="6069067"/>
            <a:ext cx="576063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zymatic activity of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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KGDH in the heart of wild-type and </a:t>
            </a:r>
            <a:r>
              <a:rPr lang="en-US" sz="1200" i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lst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-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in the heart of mice used for cellular experiments shown in </a:t>
            </a:r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5d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zymatic activity of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onitase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socitrate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hydrogenase type 2 (IDH2,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malate dehydrogenase (MDH,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in the heart of </a:t>
            </a:r>
            <a:r>
              <a:rPr lang="en-US" sz="1200" i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lst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-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and wild-type littermates divided in groups of high, intermediate and low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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KGDH activity. 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Significance was calculated using Student’s t-test for panel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) and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) and one-way ANOVA with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onferroni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post-hoc test for panels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) to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).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5034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876331" y="0"/>
            <a:ext cx="3105337" cy="40011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en-US" sz="20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0103128"/>
              </p:ext>
            </p:extLst>
          </p:nvPr>
        </p:nvGraphicFramePr>
        <p:xfrm>
          <a:off x="460375" y="902881"/>
          <a:ext cx="5937250" cy="3438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003" name="Prism 7" r:id="rId3" imgW="9760398" imgH="5645775" progId="Prism7.Document">
                  <p:embed/>
                </p:oleObj>
              </mc:Choice>
              <mc:Fallback>
                <p:oleObj name="Prism 7" r:id="rId3" imgW="9760398" imgH="564577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0375" y="902881"/>
                        <a:ext cx="5937250" cy="3438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1722294" y="68356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700642" y="22528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4013726" y="68356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4013726" y="225281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548680" y="4572000"/>
            <a:ext cx="576064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rcomere length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fractional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rcomeric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hortening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time to peak sarcomere shortening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sarcomere re-lengthening time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of isolated cardiac myocytes from </a:t>
            </a:r>
            <a:r>
              <a:rPr lang="en-US" sz="1200" i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lst</a:t>
            </a:r>
            <a:r>
              <a:rPr lang="en-US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-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and wild-type littermates divided in groups of high, intermediate and low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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KGDH activity. Cardiac myocytes were subjected to the same experimental stress protocol described for </a:t>
            </a:r>
            <a:r>
              <a:rPr lang="en-US" sz="1200" b="1" dirty="0">
                <a:solidFill>
                  <a:srgbClr val="0070C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5d-g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ce was calculated using two-way ANOVA with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onferroni’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ost-hoc test for panels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to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00563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9050">
          <a:solidFill>
            <a:srgbClr val="0070C0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4</Words>
  <Application>Microsoft Office PowerPoint</Application>
  <PresentationFormat>Bildschirmpräsentation (4:3)</PresentationFormat>
  <Paragraphs>29</Paragraphs>
  <Slides>4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10" baseType="lpstr">
      <vt:lpstr>Arial</vt:lpstr>
      <vt:lpstr>Calibri</vt:lpstr>
      <vt:lpstr>Symbol</vt:lpstr>
      <vt:lpstr>Times New Roman</vt:lpstr>
      <vt:lpstr>Larissa</vt:lpstr>
      <vt:lpstr>Prism 7</vt:lpstr>
      <vt:lpstr>PowerPoint-Präsentation</vt:lpstr>
      <vt:lpstr>PowerPoint-Präsentation</vt:lpstr>
      <vt:lpstr>PowerPoint-Präsentation</vt:lpstr>
      <vt:lpstr>PowerPoint-Präsentation</vt:lpstr>
    </vt:vector>
  </TitlesOfParts>
  <Company>UK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rtero, Edoardo</dc:creator>
  <cp:lastModifiedBy>Bertero, Edoardo</cp:lastModifiedBy>
  <cp:revision>659</cp:revision>
  <cp:lastPrinted>2019-08-22T16:34:05Z</cp:lastPrinted>
  <dcterms:created xsi:type="dcterms:W3CDTF">2017-12-08T08:21:31Z</dcterms:created>
  <dcterms:modified xsi:type="dcterms:W3CDTF">2020-07-29T11:38:56Z</dcterms:modified>
</cp:coreProperties>
</file>